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% Cytotoxicity, 50ug/ml BA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4</c:f>
              <c:strCache>
                <c:ptCount val="1"/>
                <c:pt idx="0">
                  <c:v>% Cytotoxicity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H$6:$H$15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.75086151601223428</c:v>
                  </c:pt>
                  <c:pt idx="3">
                    <c:v>8.1178820381033958</c:v>
                  </c:pt>
                  <c:pt idx="4">
                    <c:v>1.267082710385288</c:v>
                  </c:pt>
                  <c:pt idx="5">
                    <c:v>2.6690815691327923</c:v>
                  </c:pt>
                  <c:pt idx="6">
                    <c:v>3.4123517902042226</c:v>
                  </c:pt>
                  <c:pt idx="7">
                    <c:v>2.0368080193140408</c:v>
                  </c:pt>
                  <c:pt idx="8">
                    <c:v>1.5830763373842205</c:v>
                  </c:pt>
                  <c:pt idx="9">
                    <c:v>0.706715828999979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6:$A$15</c:f>
              <c:strCache>
                <c:ptCount val="10"/>
                <c:pt idx="0">
                  <c:v>Positive</c:v>
                </c:pt>
                <c:pt idx="1">
                  <c:v>Negative</c:v>
                </c:pt>
                <c:pt idx="2">
                  <c:v>BA1-40</c:v>
                </c:pt>
                <c:pt idx="3">
                  <c:v>BA1-42</c:v>
                </c:pt>
                <c:pt idx="4">
                  <c:v>BA1-34</c:v>
                </c:pt>
                <c:pt idx="5">
                  <c:v>BA1-28</c:v>
                </c:pt>
                <c:pt idx="6">
                  <c:v>BA33-40</c:v>
                </c:pt>
                <c:pt idx="7">
                  <c:v>BA35-42</c:v>
                </c:pt>
                <c:pt idx="8">
                  <c:v>BA22-40</c:v>
                </c:pt>
                <c:pt idx="9">
                  <c:v>BA22-42</c:v>
                </c:pt>
              </c:strCache>
            </c:strRef>
          </c:cat>
          <c:val>
            <c:numRef>
              <c:f>Sheet1!$F$6:$F$15</c:f>
              <c:numCache>
                <c:formatCode>0.0</c:formatCode>
                <c:ptCount val="10"/>
                <c:pt idx="0">
                  <c:v>100</c:v>
                </c:pt>
                <c:pt idx="1">
                  <c:v>0</c:v>
                </c:pt>
                <c:pt idx="2">
                  <c:v>-3.0093260162918245</c:v>
                </c:pt>
                <c:pt idx="3">
                  <c:v>5.536512852186668</c:v>
                </c:pt>
                <c:pt idx="4">
                  <c:v>-1.0225702912156416</c:v>
                </c:pt>
                <c:pt idx="5">
                  <c:v>-1.5852145889283016</c:v>
                </c:pt>
                <c:pt idx="6">
                  <c:v>-1.8937291220706849</c:v>
                </c:pt>
                <c:pt idx="7">
                  <c:v>-5.127805437763028</c:v>
                </c:pt>
                <c:pt idx="8">
                  <c:v>-4.8234652802565599</c:v>
                </c:pt>
                <c:pt idx="9">
                  <c:v>-2.53580082436794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9160344"/>
        <c:axId val="359164656"/>
      </c:barChart>
      <c:catAx>
        <c:axId val="3591603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59164656"/>
        <c:crosses val="autoZero"/>
        <c:auto val="1"/>
        <c:lblAlgn val="ctr"/>
        <c:lblOffset val="100"/>
        <c:noMultiLvlLbl val="0"/>
      </c:catAx>
      <c:valAx>
        <c:axId val="359164656"/>
        <c:scaling>
          <c:orientation val="minMax"/>
        </c:scaling>
        <c:delete val="0"/>
        <c:axPos val="l"/>
        <c:majorGridlines/>
        <c:numFmt formatCode="0.0" sourceLinked="1"/>
        <c:majorTickMark val="out"/>
        <c:minorTickMark val="none"/>
        <c:tickLblPos val="nextTo"/>
        <c:crossAx val="3591603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649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402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79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670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769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899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085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64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771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947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242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E03069-EC82-404A-B44E-F9FC75C64C36}" type="datetimeFigureOut">
              <a:rPr lang="en-US" smtClean="0"/>
              <a:t>2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94C1A-8C3D-4BEA-9EC6-23BD89B057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64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2595624"/>
              </p:ext>
            </p:extLst>
          </p:nvPr>
        </p:nvGraphicFramePr>
        <p:xfrm>
          <a:off x="3627048" y="789317"/>
          <a:ext cx="46101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95887" y="4209691"/>
            <a:ext cx="101153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DH assays (n=4). MDCK cells were treated with the indicated </a:t>
            </a:r>
            <a:r>
              <a:rPr lang="el-GR" dirty="0" smtClean="0"/>
              <a:t>β</a:t>
            </a:r>
            <a:r>
              <a:rPr lang="en-US" dirty="0" smtClean="0"/>
              <a:t>A preparations at 50 µg/ml for 45 minutes </a:t>
            </a:r>
          </a:p>
          <a:p>
            <a:r>
              <a:rPr lang="en-US" smtClean="0"/>
              <a:t>At 37°C </a:t>
            </a:r>
            <a:r>
              <a:rPr lang="en-US" dirty="0" smtClean="0"/>
              <a:t>as in the infectious focus assay. LDH was measured by ELISA assay at 18 hr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5908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5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Boston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tshorn, Kevan</dc:creator>
  <cp:lastModifiedBy>Hartshorn, Kevan</cp:lastModifiedBy>
  <cp:revision>3</cp:revision>
  <dcterms:created xsi:type="dcterms:W3CDTF">2018-02-09T21:30:15Z</dcterms:created>
  <dcterms:modified xsi:type="dcterms:W3CDTF">2018-02-09T21:41:46Z</dcterms:modified>
</cp:coreProperties>
</file>